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8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8130" y="0"/>
            <a:ext cx="1253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Figure S</a:t>
            </a:r>
            <a:r>
              <a:rPr lang="en-US" altLang="zh-TW" dirty="0"/>
              <a:t>4</a:t>
            </a:r>
            <a:endParaRPr lang="en-US" altLang="zh-HK" dirty="0"/>
          </a:p>
        </p:txBody>
      </p:sp>
      <p:sp>
        <p:nvSpPr>
          <p:cNvPr id="3" name="TextBox 2"/>
          <p:cNvSpPr txBox="1"/>
          <p:nvPr/>
        </p:nvSpPr>
        <p:spPr>
          <a:xfrm>
            <a:off x="142673" y="62068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0713" y="33477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989784" y="6206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987824" y="33477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d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732790" y="62068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e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67" y="1011984"/>
            <a:ext cx="2685789" cy="205473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67" y="3848745"/>
            <a:ext cx="2738781" cy="210053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0299" y="1159200"/>
            <a:ext cx="2538894" cy="187234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3513" y="4027480"/>
            <a:ext cx="2538894" cy="187234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067944" y="908720"/>
            <a:ext cx="76174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77" dirty="0"/>
              <a:t>MCF-7</a:t>
            </a:r>
            <a:endParaRPr lang="zh-HK" altLang="en-US" sz="1477" dirty="0"/>
          </a:p>
        </p:txBody>
      </p:sp>
      <p:sp>
        <p:nvSpPr>
          <p:cNvPr id="13" name="TextBox 12"/>
          <p:cNvSpPr txBox="1"/>
          <p:nvPr/>
        </p:nvSpPr>
        <p:spPr>
          <a:xfrm>
            <a:off x="4204021" y="3781806"/>
            <a:ext cx="71045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77" dirty="0"/>
              <a:t>ZR-75</a:t>
            </a:r>
            <a:endParaRPr lang="zh-HK" altLang="en-US" sz="1477" dirty="0"/>
          </a:p>
        </p:txBody>
      </p:sp>
      <p:grpSp>
        <p:nvGrpSpPr>
          <p:cNvPr id="14" name="Group 13"/>
          <p:cNvGrpSpPr/>
          <p:nvPr/>
        </p:nvGrpSpPr>
        <p:grpSpPr>
          <a:xfrm>
            <a:off x="5746244" y="908720"/>
            <a:ext cx="3384328" cy="2031459"/>
            <a:chOff x="5624555" y="941910"/>
            <a:chExt cx="4095720" cy="2539244"/>
          </a:xfrm>
        </p:grpSpPr>
        <p:grpSp>
          <p:nvGrpSpPr>
            <p:cNvPr id="15" name="Group 14"/>
            <p:cNvGrpSpPr/>
            <p:nvPr/>
          </p:nvGrpSpPr>
          <p:grpSpPr>
            <a:xfrm>
              <a:off x="5624555" y="1307083"/>
              <a:ext cx="4095720" cy="2174071"/>
              <a:chOff x="5701365" y="954093"/>
              <a:chExt cx="4095720" cy="2174071"/>
            </a:xfrm>
          </p:grpSpPr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949" t="27040" r="33365" b="61760"/>
              <a:stretch/>
            </p:blipFill>
            <p:spPr>
              <a:xfrm>
                <a:off x="6438857" y="1775308"/>
                <a:ext cx="2463069" cy="1352856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5837640" y="2152537"/>
                <a:ext cx="720112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eIF4E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701365" y="2451134"/>
                <a:ext cx="865609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FOXM1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722676" y="2755128"/>
                <a:ext cx="823783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Tubulin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8897540" y="1830708"/>
                <a:ext cx="811290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66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8897540" y="2137947"/>
                <a:ext cx="811290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8896790" y="2752428"/>
                <a:ext cx="811290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8896789" y="2462605"/>
                <a:ext cx="900296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10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5961074" y="1861487"/>
                <a:ext cx="578496" cy="346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ER</a:t>
                </a:r>
                <a:r>
                  <a:rPr lang="el-GR" sz="1200" dirty="0">
                    <a:latin typeface="Minion Pro Med" panose="02040503050201020203" pitchFamily="18" charset="0"/>
                  </a:rPr>
                  <a:t>α</a:t>
                </a:r>
                <a:endParaRPr lang="en-US" sz="1200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6448293" y="1573282"/>
                <a:ext cx="295263" cy="3847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400" dirty="0"/>
                  <a:t>-</a:t>
                </a:r>
                <a:endParaRPr lang="zh-HK" altLang="en-US" sz="14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6200000">
                <a:off x="6500959" y="1444625"/>
                <a:ext cx="667630" cy="335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 err="1"/>
                  <a:t>siCtrl</a:t>
                </a:r>
                <a:endParaRPr lang="zh-HK" altLang="en-US" sz="12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6200000">
                <a:off x="6638524" y="1291536"/>
                <a:ext cx="986218" cy="335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1</a:t>
                </a:r>
                <a:endParaRPr lang="zh-HK" altLang="en-US" sz="1200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6200000">
                <a:off x="6932720" y="1292073"/>
                <a:ext cx="986218" cy="335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2</a:t>
                </a:r>
                <a:endParaRPr lang="zh-HK" altLang="en-US" sz="1200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7725937" y="1561334"/>
                <a:ext cx="295263" cy="3847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400" dirty="0"/>
                  <a:t>-</a:t>
                </a:r>
                <a:endParaRPr lang="zh-HK" altLang="en-US" sz="14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6200000">
                <a:off x="7754084" y="1449191"/>
                <a:ext cx="667630" cy="335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 err="1"/>
                  <a:t>siCtrl</a:t>
                </a:r>
                <a:endParaRPr lang="zh-HK" altLang="en-US" sz="12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6200000">
                <a:off x="7869918" y="1279589"/>
                <a:ext cx="986218" cy="335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1</a:t>
                </a:r>
                <a:endParaRPr lang="zh-HK" altLang="en-US" sz="1200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6200000">
                <a:off x="8153245" y="1280127"/>
                <a:ext cx="986218" cy="335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2</a:t>
                </a:r>
                <a:endParaRPr lang="zh-HK" altLang="en-US" sz="1200" dirty="0"/>
              </a:p>
            </p:txBody>
          </p:sp>
        </p:grpSp>
        <p:cxnSp>
          <p:nvCxnSpPr>
            <p:cNvPr id="16" name="Straight Connector 15"/>
            <p:cNvCxnSpPr/>
            <p:nvPr/>
          </p:nvCxnSpPr>
          <p:spPr>
            <a:xfrm>
              <a:off x="6373985" y="1293101"/>
              <a:ext cx="1057448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7718160" y="1291530"/>
              <a:ext cx="1057448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6527604" y="941910"/>
              <a:ext cx="791890" cy="3462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200" dirty="0"/>
                <a:t>MCF-7</a:t>
              </a:r>
              <a:endParaRPr lang="zh-HK" altLang="en-US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884806" y="944351"/>
              <a:ext cx="739512" cy="3462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200" dirty="0"/>
                <a:t>ZR-75</a:t>
              </a:r>
              <a:endParaRPr lang="zh-HK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93412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6</TotalTime>
  <Words>32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Minion Pro Med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100</cp:revision>
  <cp:lastPrinted>2019-05-24T08:26:42Z</cp:lastPrinted>
  <dcterms:created xsi:type="dcterms:W3CDTF">2017-10-03T01:31:32Z</dcterms:created>
  <dcterms:modified xsi:type="dcterms:W3CDTF">2020-01-29T02:58:46Z</dcterms:modified>
</cp:coreProperties>
</file>